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2347" autoAdjust="0"/>
    <p:restoredTop sz="90873" autoAdjust="0"/>
  </p:normalViewPr>
  <p:slideViewPr>
    <p:cSldViewPr snapToGrid="0" snapToObjects="1">
      <p:cViewPr>
        <p:scale>
          <a:sx n="150" d="100"/>
          <a:sy n="150" d="100"/>
        </p:scale>
        <p:origin x="-80" y="-1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50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52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366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7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067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23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812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663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894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494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814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429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517" y="410340"/>
            <a:ext cx="2662562" cy="287226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9485" y="426840"/>
            <a:ext cx="2662561" cy="2872262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5432" y="426840"/>
            <a:ext cx="2719753" cy="2872262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81926" y="3560980"/>
            <a:ext cx="2662561" cy="2872262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5313" y="3467082"/>
            <a:ext cx="2662765" cy="2953137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57217" y="3098851"/>
            <a:ext cx="2560963" cy="3300525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 rot="16200000">
            <a:off x="-1322748" y="1382754"/>
            <a:ext cx="32042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alveolar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CD68)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1605745" y="1382757"/>
            <a:ext cx="33753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1200" dirty="0" smtClean="0">
                <a:latin typeface="Helvetica"/>
                <a:cs typeface="Helvetica"/>
              </a:rPr>
              <a:t>CD</a:t>
            </a:r>
            <a:r>
              <a:rPr kumimoji="1" lang="en-US" altLang="ja-JP" sz="1200" dirty="0" smtClean="0">
                <a:latin typeface="Helvetica"/>
                <a:cs typeface="Helvetica"/>
              </a:rPr>
              <a:t>1</a:t>
            </a:r>
            <a:r>
              <a:rPr kumimoji="1" lang="en-US" altLang="ja-JP" sz="1200" dirty="0" smtClean="0">
                <a:latin typeface="Helvetica"/>
                <a:cs typeface="Helvetica"/>
              </a:rPr>
              <a:t>6</a:t>
            </a:r>
            <a:r>
              <a:rPr kumimoji="1" lang="en-US" altLang="ja-JP" sz="1200" dirty="0" smtClean="0">
                <a:latin typeface="Helvetica"/>
                <a:cs typeface="Helvetica"/>
              </a:rPr>
              <a:t>3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alveolar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-1361178" y="4633893"/>
            <a:ext cx="32810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err="1" smtClean="0">
                <a:latin typeface="Helvetica"/>
                <a:cs typeface="Helvetica"/>
              </a:rPr>
              <a:t>interstital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CD68)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1593013" y="4633896"/>
            <a:ext cx="34008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1200" dirty="0" smtClean="0">
                <a:latin typeface="Helvetica"/>
                <a:cs typeface="Helvetica"/>
              </a:rPr>
              <a:t>CD</a:t>
            </a:r>
            <a:r>
              <a:rPr kumimoji="1" lang="en-US" altLang="ja-JP" sz="1200" dirty="0" smtClean="0">
                <a:latin typeface="Helvetica"/>
                <a:cs typeface="Helvetica"/>
              </a:rPr>
              <a:t>1</a:t>
            </a:r>
            <a:r>
              <a:rPr kumimoji="1" lang="en-US" altLang="ja-JP" sz="1200" dirty="0" smtClean="0">
                <a:latin typeface="Helvetica"/>
                <a:cs typeface="Helvetica"/>
              </a:rPr>
              <a:t>6</a:t>
            </a:r>
            <a:r>
              <a:rPr kumimoji="1" lang="en-US" altLang="ja-JP" sz="1200" dirty="0" smtClean="0">
                <a:latin typeface="Helvetica"/>
                <a:cs typeface="Helvetica"/>
              </a:rPr>
              <a:t>3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4648897" y="1347132"/>
            <a:ext cx="31015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ratio of CD163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alveolar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>
                <a:latin typeface="Helvetica"/>
                <a:cs typeface="Helvetica"/>
              </a:rPr>
              <a:t>CD68</a:t>
            </a:r>
            <a:r>
              <a:rPr lang="en-US" altLang="ja-JP" sz="1200" baseline="30000" dirty="0">
                <a:latin typeface="Helvetica"/>
                <a:cs typeface="Helvetica"/>
              </a:rPr>
              <a:t>+</a:t>
            </a:r>
            <a:r>
              <a:rPr lang="en-US" altLang="ja-JP" sz="1200" dirty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alveolar </a:t>
            </a:r>
            <a:r>
              <a:rPr lang="en-US" altLang="ja-JP" sz="1200" dirty="0" smtClean="0">
                <a:latin typeface="Helvetica"/>
                <a:cs typeface="Helvetica"/>
              </a:rPr>
              <a:t>macrophages</a:t>
            </a:r>
            <a:endParaRPr lang="en-US" altLang="ja-JP" sz="1200" dirty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CD163)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iCD68)]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4636168" y="4564405"/>
            <a:ext cx="31270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ratio of </a:t>
            </a:r>
            <a:r>
              <a:rPr kumimoji="1" lang="en-US" altLang="ja-JP" sz="1200" dirty="0" smtClean="0">
                <a:latin typeface="Helvetica"/>
                <a:cs typeface="Helvetica"/>
              </a:rPr>
              <a:t>CD6</a:t>
            </a:r>
            <a:r>
              <a:rPr kumimoji="1" lang="en-US" altLang="ja-JP" sz="1200" dirty="0" smtClean="0">
                <a:latin typeface="Helvetica"/>
                <a:cs typeface="Helvetica"/>
              </a:rPr>
              <a:t>8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  <a:endParaRPr kumimoji="1" lang="en-US" altLang="ja-JP" sz="1200" dirty="0" smtClean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macrophages</a:t>
            </a:r>
            <a:endParaRPr lang="en-US" altLang="ja-JP" sz="1200" dirty="0">
              <a:latin typeface="Helvetica"/>
              <a:cs typeface="Helvetica"/>
            </a:endParaRP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CD6</a:t>
            </a:r>
            <a:r>
              <a:rPr lang="en-US" altLang="ja-JP" sz="1200" dirty="0" smtClean="0">
                <a:latin typeface="Helvetica"/>
                <a:cs typeface="Helvetica"/>
              </a:rPr>
              <a:t>8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i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25536" y="2967932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292487" y="3060265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84483" y="3060265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396054" y="3060265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410990" y="2967932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277941" y="3060265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769937" y="3060265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381508" y="3060265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481109" y="2967932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348060" y="3060265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7840056" y="3060265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8451627" y="3060265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08606" y="6032808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275557" y="6125141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767553" y="6125141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379124" y="6125141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394060" y="6032808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261011" y="6125141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753007" y="6125141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364578" y="6125141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6464179" y="6032808"/>
            <a:ext cx="1036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Healthy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control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7331130" y="6125141"/>
            <a:ext cx="441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U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7823126" y="6125141"/>
            <a:ext cx="543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NSI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8434697" y="6125141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COP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973667" y="304800"/>
            <a:ext cx="1744133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973667" y="457200"/>
            <a:ext cx="1092205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973667" y="609600"/>
            <a:ext cx="471698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/>
          <p:cNvSpPr txBox="1"/>
          <p:nvPr/>
        </p:nvSpPr>
        <p:spPr>
          <a:xfrm>
            <a:off x="1709947" y="1025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388195" y="263367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024108" y="42423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49" name="直線コネクタ 48"/>
          <p:cNvCxnSpPr/>
          <p:nvPr/>
        </p:nvCxnSpPr>
        <p:spPr>
          <a:xfrm>
            <a:off x="3894776" y="304794"/>
            <a:ext cx="1744133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4546704" y="457194"/>
            <a:ext cx="1092205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3894776" y="609594"/>
            <a:ext cx="1151468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4430811" y="761994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/>
          <p:cNvSpPr txBox="1"/>
          <p:nvPr/>
        </p:nvSpPr>
        <p:spPr>
          <a:xfrm>
            <a:off x="4555776" y="10250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4860053" y="262939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216026" y="423378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528770" y="57535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59" name="直線コネクタ 58"/>
          <p:cNvCxnSpPr/>
          <p:nvPr/>
        </p:nvCxnSpPr>
        <p:spPr>
          <a:xfrm>
            <a:off x="6959824" y="203184"/>
            <a:ext cx="1744133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7611752" y="355584"/>
            <a:ext cx="1092205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6959824" y="507984"/>
            <a:ext cx="1151468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7495859" y="660384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/>
          <p:cNvSpPr txBox="1"/>
          <p:nvPr/>
        </p:nvSpPr>
        <p:spPr>
          <a:xfrm>
            <a:off x="7602639" y="-3052"/>
            <a:ext cx="36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7960298" y="164723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7374024" y="30175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7604678" y="47799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82" name="直線コネクタ 81"/>
          <p:cNvCxnSpPr/>
          <p:nvPr/>
        </p:nvCxnSpPr>
        <p:spPr>
          <a:xfrm>
            <a:off x="946669" y="4030132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/>
          <p:cNvSpPr txBox="1"/>
          <p:nvPr/>
        </p:nvSpPr>
        <p:spPr>
          <a:xfrm>
            <a:off x="1130942" y="3829336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84" name="直線コネクタ 83"/>
          <p:cNvCxnSpPr/>
          <p:nvPr/>
        </p:nvCxnSpPr>
        <p:spPr>
          <a:xfrm>
            <a:off x="3903237" y="3589984"/>
            <a:ext cx="1744133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4555165" y="3742384"/>
            <a:ext cx="1092205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>
            <a:off x="3903237" y="3894784"/>
            <a:ext cx="1151468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>
            <a:off x="4439272" y="4047184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/>
          <p:cNvSpPr txBox="1"/>
          <p:nvPr/>
        </p:nvSpPr>
        <p:spPr>
          <a:xfrm>
            <a:off x="4564237" y="338769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4868514" y="3548129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4224487" y="3708568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4537231" y="386054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94" name="直線コネクタ 93"/>
          <p:cNvCxnSpPr/>
          <p:nvPr/>
        </p:nvCxnSpPr>
        <p:spPr>
          <a:xfrm>
            <a:off x="6855025" y="3708568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>
            <a:off x="7535031" y="3708568"/>
            <a:ext cx="6239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>
            <a:off x="7535031" y="3589984"/>
            <a:ext cx="1151468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/>
          <p:cNvSpPr txBox="1"/>
          <p:nvPr/>
        </p:nvSpPr>
        <p:spPr>
          <a:xfrm>
            <a:off x="6992762" y="3526189"/>
            <a:ext cx="36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7707480" y="353402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8016888" y="3399784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467418" y="45813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A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3484617" y="45813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B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6425613" y="45813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C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505984" y="3371355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3523183" y="3371355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E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6464179" y="3371355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F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2742384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235</Words>
  <Application>Microsoft Macintosh PowerPoint</Application>
  <PresentationFormat>画面に合わせる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岩手医科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下 雅大</dc:creator>
  <cp:lastModifiedBy>山下 雅大</cp:lastModifiedBy>
  <cp:revision>17</cp:revision>
  <dcterms:created xsi:type="dcterms:W3CDTF">2017-12-30T07:27:18Z</dcterms:created>
  <dcterms:modified xsi:type="dcterms:W3CDTF">2017-12-30T10:20:31Z</dcterms:modified>
</cp:coreProperties>
</file>